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7"/>
    <a:srgbClr val="99FF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 autoAdjust="0"/>
    <p:restoredTop sz="95139" autoAdjust="0"/>
  </p:normalViewPr>
  <p:slideViewPr>
    <p:cSldViewPr>
      <p:cViewPr varScale="1">
        <p:scale>
          <a:sx n="116" d="100"/>
          <a:sy n="116" d="100"/>
        </p:scale>
        <p:origin x="104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2333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21AE8-B305-4190-935A-A6C830857FE3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630FF-F02B-4626-82E1-C46299F89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605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DDAC483-7313-4644-970F-0EDFC3A106FE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EC04829-1CB9-4F51-8A07-D65AE5A98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79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6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0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93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9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6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CB72-9C25-4AD7-B59B-5176EE691596}" type="datetimeFigureOut">
              <a:rPr lang="en-US" smtClean="0"/>
              <a:t>8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12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3C179B1-A660-40DE-B16B-6CEF922C4B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9442" y="340842"/>
            <a:ext cx="8145116" cy="36576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65EF30A8-D4C3-4E94-A288-7D74DDAA7BBF}"/>
              </a:ext>
            </a:extLst>
          </p:cNvPr>
          <p:cNvSpPr/>
          <p:nvPr/>
        </p:nvSpPr>
        <p:spPr>
          <a:xfrm>
            <a:off x="304800" y="4191000"/>
            <a:ext cx="86106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</a:rPr>
              <a:t>Additional file 3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QTL analysis results of the combined SJ.HD-N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+ SJ.HD-F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cohorts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SJ.HD-N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16 affected, 17 unaffected) and SJ.HD-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(22 affected, 22 unaffected) were combined and run as a </a:t>
            </a:r>
            <a:r>
              <a:rPr lang="en-US" sz="1600" b="1" u="sng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single population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(n=77) using an 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scenario in R/</a:t>
            </a:r>
            <a:r>
              <a:rPr lang="en-US" sz="1600" dirty="0" err="1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qtl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A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Genomewide plot. 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B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Chromosome 17 plot. The same highly significant QTLs seen in separate N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Fig. 4A; chromosome 5) and 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Fig. 4B; chromosome 17) analyses, were all identified in this combined analysis. In addition, a new putative significant locus was revealed on chromosome 1. Suggestive (p&lt;0.67), significant (p&lt;0.05) and highly significant (p&lt;0.01) thresholds for linkage are as indicated in A and determined by 1000 permutations of the respective datasets.</a:t>
            </a:r>
            <a:endParaRPr lang="en-US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9004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lIns="0" tIns="0" rIns="0" bIns="0" rtlCol="0">
        <a:spAutoFit/>
      </a:bodyPr>
      <a:lstStyle>
        <a:defPPr algn="r">
          <a:lnSpc>
            <a:spcPts val="5700"/>
          </a:lnSpc>
          <a:defRPr sz="14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853</TotalTime>
  <Words>16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Mincho</vt:lpstr>
      <vt:lpstr>Arial</vt:lpstr>
      <vt:lpstr>Calibri</vt:lpstr>
      <vt:lpstr>Times New Roman</vt:lpstr>
      <vt:lpstr>Office Theme</vt:lpstr>
      <vt:lpstr>PowerPoint Presentation</vt:lpstr>
    </vt:vector>
  </TitlesOfParts>
  <Company>CCH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prop73</cp:lastModifiedBy>
  <cp:revision>331</cp:revision>
  <cp:lastPrinted>2019-04-17T14:37:59Z</cp:lastPrinted>
  <dcterms:created xsi:type="dcterms:W3CDTF">2012-04-10T18:38:20Z</dcterms:created>
  <dcterms:modified xsi:type="dcterms:W3CDTF">2019-08-26T13:35:49Z</dcterms:modified>
</cp:coreProperties>
</file>